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44E89-64B8-46B6-A473-6BE80AB2D8D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49991B-C3E4-4AA4-B4CF-E176380569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347CFB-57F7-49CE-847C-EBD21D1CBA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5B934-5D7F-4BCC-ABA5-C524AB261C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23F98-C4B0-483D-B7DF-1B756FB3A5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77061-7122-4A8F-96BC-E73C3BB85A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D8C2B-93E0-4267-B4C6-CC89BA0401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C506CD-5137-4707-A889-DD79952EB1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8C3E4E-2961-44B8-9912-FED3704CD7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C7EFE-483E-4E56-9EDE-5CB3939DFD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7E0613-1678-4B03-BAC3-6C7D521011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A0F7A-FE02-44FD-B406-27F3D67765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AA4F36-A945-43FD-BD13-727D2BB548A6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0" t="56850" r="0" b="0"/>
          <a:stretch/>
        </p:blipFill>
        <p:spPr>
          <a:xfrm>
            <a:off x="1743120" y="3071880"/>
            <a:ext cx="5257800" cy="168120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5"/>
          <p:cNvSpPr/>
          <p:nvPr/>
        </p:nvSpPr>
        <p:spPr>
          <a:xfrm>
            <a:off x="642960" y="4860000"/>
            <a:ext cx="77868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 Meningococcal CrgA and PBP1 as well as PBP2 from Helicobacter pylori do not bind TLR4.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mmunoprecipitation studies showing that meningococcal PBP2 but not the other proteins studied co immunoprecipitates with TLR4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20T18:58:38Z</dcterms:created>
  <dc:creator>NAT_2010</dc:creator>
  <dc:description/>
  <dc:language>en-US</dc:language>
  <cp:lastModifiedBy> </cp:lastModifiedBy>
  <dcterms:modified xsi:type="dcterms:W3CDTF">2011-09-26T14:19:46Z</dcterms:modified>
  <cp:revision>3</cp:revision>
  <dc:subject/>
  <dc:title>Diapositive 1</dc:title>
</cp:coreProperties>
</file>